
<file path=[Content_Types].xml><?xml version="1.0" encoding="utf-8"?>
<Types xmlns="http://schemas.openxmlformats.org/package/2006/content-types">
  <Default Extension="avi" ContentType="video/x-msvideo"/>
  <Default Extension="emf" ContentType="image/x-emf"/>
  <Default Extension="gif" ContentType="image/gi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ink/ink1.xml" ContentType="application/inkml+xml"/>
  <Override PartName="/ppt/ink/ink2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1032" r:id="rId2"/>
    <p:sldId id="37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70"/>
    <p:restoredTop sz="96327"/>
  </p:normalViewPr>
  <p:slideViewPr>
    <p:cSldViewPr snapToGrid="0">
      <p:cViewPr varScale="1">
        <p:scale>
          <a:sx n="117" d="100"/>
          <a:sy n="117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28T14:55:03.768"/>
    </inkml:context>
    <inkml:brush xml:id="br0">
      <inkml:brushProperty name="width" value="0.025" units="cm"/>
      <inkml:brushProperty name="height" value="0.025" units="cm"/>
      <inkml:brushProperty name="color" value="#FFFFFF"/>
    </inkml:brush>
  </inkml:definitions>
  <inkml:trace contextRef="#ctx0" brushRef="#br0">0 279 24575,'11'1'0,"-5"-1"0,40 3 0,-18-3 0,17 1 0,-21-1 0,-13 0 0,-1 0 0,-3 0 0,0 0 0,-5 0 0,0 0 0,0 0 0,0 0 0,2 0 0,-3 0 0,2 0 0,-2 0 0,0 0 0,1 0 0,2 0 0,-2 0 0,1 0 0,-2 0 0,6 0 0,1 0 0,4 0 0,4 0 0,-3 0 0,1 1 0,-6-1 0,-3 2 0,-1-2 0,-1 0 0,-1 0 0,0 0 0,-1 0 0,2 0 0,-1 1 0,2-1 0,-1 1 0,2-1 0,2 3 0,1-2 0,4 1 0,-3-2 0,2 1 0,2 0 0,-2-1 0,1 4 0,-5-4 0,-1 0 0,0 0 0,0 2 0,0-1 0,2-1 0,-3 1 0,2-1 0,-3 0 0,-3 0 0,2 2 0,1-2 0,0 0 0,0 0 0,2 1 0,1-1 0,1 3 0,0-2 0,0-1 0,0 1 0,-1 1 0,1-2 0,-3 0 0,2 1 0,-3-1 0,1 1 0,3-1 0,-3 0 0,5 3 0,-5-3 0,3 1 0,-1-1 0,-2 0 0,-2 0 0,3 2 0,-3-2 0,4 0 0,-1 1 0,1 0 0,2-1 0,2 4 0,-2-4 0,2 2 0,-2-2 0,1 1 0,-5-1 0,0 1 0,-2-1 0,-2 0 0,2 0 0,1 0 0,3 2 0,1-2 0,0 1 0,0-1 0,0 0 0,0 3 0,1-3 0,0 1 0,2-1 0,1 0 0,-4 0 0,-4 0 0,-1 0 0,-1 0 0,2 0 0,-1 0 0,1 0 0,1 0 0,-2 1 0,2-1 0,-2 0 0,2 0 0,-1 2 0,4-2 0,3 0 0,-2 0 0,1 0 0,-2 1 0,-3-1 0,0 3 0,2-3 0,-2 0 0,2 0 0,-2 0 0,1 0 0,-2 0 0,1 0 0,2 0 0,-2 0 0,0 0 0,-1 0 0,-1 0 0,4 0 0,-6 0 0,3 0 0,0 0 0,1 0 0,1 0 0,0 0 0,1 0 0,2 0 0,1 0 0,-2 1 0,0-1 0,-3 0 0,0 0 0,1 0 0,-2 0 0,4 0 0,-2 0 0,4 0 0,-1 0 0,-4 0 0,1 0 0,-4 0 0,1 0 0,0 0 0,2 0 0,-1 0 0,4 0 0,-1 0 0,1 0 0,-4 0 0,4 0 0,-2 0 0,2 0 0,-1 0 0,1 0 0,-1 0 0,1 0 0,-3 0 0,2 0 0,-1 0 0,2 0 0,-1 0 0,1 0 0,0 0 0,-1 0 0,1 0 0,-3-1 0,4 1 0,-3 0 0,4 0 0,0 0 0,0 0 0,-2 0 0,4 0 0,-1 0 0,1 0 0,-5 0 0,6-3 0,-2 3 0,3-1 0,0 1 0,-4 0 0,1 0 0,-2 0 0,-1 0 0,0 0 0,0 0 0,3 0 0,0-2 0,-1 2 0,2 0 0,0-1 0,4 1 0,-4-1 0,3-2 0,-6 3 0,-1-3 0,0 3 0,0-1 0,0 0 0,0 1 0,-4-2 0,2 2 0,0-2 0,5 0 0,-4 2 0,3-1 0,1 0 0,-6 1 0,3-2 0,-4 2 0,3-1 0,-3 1 0,1 0 0,2 0 0,-3 0 0,0-3 0,1 3 0,1-1 0,0 1 0,1-1 0,4 1 0,-1-2 0,5 1 0,-2-3 0,1 3 0,-1-1 0,3 2 0,-3-2 0,1 0 0,-1 0 0,-4 0 0,3 2 0,-6-1 0,2 1 0,-4 0 0,2 0 0,0 0 0,3 0 0,-1-1 0,3 1 0,-1-2 0,6 1 0,-1-2 0,9 1 0,-8 2 0,7-3 0,-7 2 0,4-2 0,-8 2 0,0-1 0,-6 1 0,2 1 0,-2-1 0,3 1 0,-1 0 0,1-2 0,3 0 0,4 0 0,3 1 0,0-2 0,-2 2 0,-5-2 0,0 1 0,0 2 0,0-3 0,0 3 0,1-4 0,-3 3 0,-2-1 0,0 1 0,1-2 0,-2 1 0,3 0 0,1 0 0,1-1 0,-3-1 0,1 1 0,0-1 0,-4 3 0,4-3 0,-2 3 0,4-3 0,-6 2 0,2 1 0,-3 1 0,0-1 0,2-1 0,-3 0 0,3 0 0,-2 1 0,3 0 0,0-5 0,0 4 0,3-1 0,-2-2 0,4-1 0,1 0 0,-2-2 0,1 4 0,-1-4 0,1 1 0,-3 3 0,-2-1 0,-3 2 0,-1 2 0,0-2 0,-1 3 0,-1-1 0,0 1 0,2-2 0,2 1 0,4-2 0,0-1 0,1 2 0,1-1 0,0 0 0,1 1 0,-1 0 0,4-2 0,-2 3 0,-1-2 0,2 2 0,-5 0 0,2-3 0,-1 4 0,2-3 0,-2 3 0,4-3 0,-2 3 0,11-4 0,-7 3 0,6-2 0,-8 3 0,2-4 0,-1 3 0,3 0 0,-7-2 0,-2 3 0,1-4 0,0 4 0,1-1 0,2-1 0,4 2 0,0-2 0,1 2 0,-6 0 0,-1-2 0,-1 2 0,0-2 0,-3 2 0,0 0 0,-3 0 0,2 0 0,-3 0 0,2-2 0,-3 2 0,2 0 0,-2 0 0,4 0 0,-3 0 0,4 0 0,-3 0 0,3 0 0,-1 0 0,11 0 0,-2-1 0,6 0 0,-4 1 0,-6-2 0,0 2 0,-6-1 0,0 1 0,-3-3 0,0 3 0,-2 0 0,0 0 0,3 0 0,-1 0 0,1 0 0,3 0 0,1 0 0,2 0 0,10 0 0,-5 0 0,5 0 0,-5 0 0,-2 0 0,-4 0 0,-2 0 0,-2 0 0,-3 0 0,0 0 0,2 0 0,-1 0 0,1 0 0,0 0 0,3 0 0,-2 0 0,2 0 0,-1 0 0,2 0 0,2 0 0,3 0 0,4 0 0,2 0 0,1 0 0,-5 0 0,-1-1 0,-4 1 0,0 0 0,-4 0 0,-1 0 0,0 0 0,-1 0 0,0 0 0,2 0 0,0 0 0,2 0 0,6-1 0,-5 1 0,4-2 0,-5 2 0,3 0 0,-2-1 0,3 1 0,0 0 0,6 0 0,-4 0 0,5 0 0,0 0 0,1-1 0,1 1 0,2 0 0,-5 0 0,4-3 0,-2 3 0,0-1 0,0 1 0,-3 0 0,-4-2 0,-3 2 0,0 0 0,0 0 0,0 0 0,5 0 0,6 0 0,1 0 0,7 0 0,-8 0 0,1-1 0,-5 1 0,-4-1 0,-5-1 0,-1 2 0,-3-2 0,-3 2 0,1-2 0,0 2 0,0 0 0,0 0 0,0-1 0,2 1 0,2-1 0,1 1 0,4-2 0,2 1 0,0 1 0,2-3 0,-2 3 0,-1 0 0,-1 0 0,-2-1 0,-1 1 0,-1-1 0,0 1 0,1 0 0,-2-2 0,2 1 0,0 1 0,-1 0 0,1 0 0,-3 0 0,2 0 0,-3 0 0,1 0 0,1 0 0,-2 0 0,1 0 0,2 0 0,-2 0 0,2 0 0,-3 0 0,2 0 0,0 0 0,0 0 0,2 0 0,4 0 0,8 0 0,-2 0 0,7 0 0,-9 0 0,1 0 0,-5-1 0,3 1 0,-6-3 0,5 3 0,-5 0 0,2 0 0,-6 0 0,3 0 0,-3 0 0,1 0 0,-1 0 0,0 0 0,5 0 0,-4 0 0,4 0 0,-1 0 0,3 0 0,-4 0 0,5 0 0,-5 0 0,3 0 0,-4 0 0,5 0 0,-2 0 0,5 0 0,-2-1 0,3 1 0,0 0 0,3-2 0,-2 2 0,3 0 0,-2 0 0,-1 0 0,0 0 0,-3 0 0,-2 0 0,1 0 0,-4 0 0,7 0 0,-2 0 0,-1 0 0,0 0 0,-3 0 0,2 0 0,-2 0 0,4 0 0,-1 0 0,2 0 0,-2 0 0,3 0 0,-4 0 0,7-1 0,-5 1 0,2-1 0,-6 1 0,-1 0 0,-2 0 0,1 0 0,0 0 0,1 0 0,2 0 0,-3 0 0,2 0 0,2 0 0,0 0 0,-1 0 0,1 0 0,-4 0 0,3 0 0,-1 0 0,1 0 0,-3 0 0,1-2 0,-1 2 0,0 0 0,2 0 0,2 0 0,-2 0 0,1 0 0,0 0 0,-1 0 0,0 0 0,-2 0 0,-2 0 0,1 0 0,1 0 0,1 0 0,1 0 0,-1 0 0,3 0 0,-3 0 0,5 0 0,-2 0 0,4 0 0,0 0 0,5 0 0,-2 0 0,-2 0 0,-4 0 0,5 0 0,-1 0 0,2 0 0,-1 0 0,1 0 0,-7 0 0,1 0 0,1 0 0,-4 0 0,4 0 0,-4 0 0,1 0 0,-2 0 0,5 0 0,3 0 0,4 0 0,-1 0 0,4 0 0,-5 0 0,2 0 0,-6 0 0,4 0 0,-7 0 0,2 0 0,-2-2 0,0 2 0,-2 0 0,2 0 0,-2 0 0,6 0 0,-1 0 0,1 0 0,0 0 0,0-2 0,1 2 0,-3-1 0,-1 1 0,-4 0 0,2 0 0,2 0 0,-1 0 0,2 0 0,2 0 0,0 0 0,2 0 0,-3 0 0,0 0 0,-6 0 0,0 0 0,-2 0 0,2 0 0,-3 0 0,2 0 0,-3 0 0,2 0 0,-1 0 0,2 1 0,4-1 0,-1 2 0,5-2 0,0 0 0,1 0 0,-2 0 0,1 0 0,-8 0 0,3 0 0,-1 4 0,1-4 0,-2 1 0,5 0 0,-1 1 0,7-1 0,-5 2 0,2-2 0,-4 0 0,3 1 0,-6-2 0,0 1 0,1-1 0,-2 1 0,2-1 0,1 3 0,3-2 0,1-1 0,2 2 0,-2-2 0,-1 0 0,1 0 0,-1 1 0,-3-1 0,4 1 0,-4-1 0,1 2 0,-4-2 0,2 0 0,-4 0 0,-1 0 0,0 0 0,-2 0 0,1 0 0,0 0 0,1 0 0,3 0 0,3 2 0,1-2 0,3 3 0,2 0 0,8 1 0,-2 0 0,4 1 0,-6-2 0,-4-1 0,-4 0 0,0 0 0,-3 0 0,0-1 0,1 0 0,1 1 0,0 2 0,-2-3 0,-3 0 0,0 2 0,0-2 0,-1 2 0,1-2 0,-2-1 0,1 2 0,-2-2 0,2 1 0,-2-1 0,1 3 0,-1-3 0,0 2 0,3 0 0,3-1 0,1 2 0,3 2 0,-2-1 0,2 0 0,-2 0 0,0 0 0,-5-3 0,4 3 0,-2 0 0,2-1 0,5 5 0,3 0 0,4-1 0,-8-1 0,-1 0 0,-6-5 0,0 0 0,-2 1 0,0-1 0,-1 3 0,1-3 0,0 1 0,-2 0 0,2-2 0,-3 2 0,2 0 0,1 0 0,1 0 0,4 1 0,-1 2 0,2-1 0,-1 0 0,1-2 0,-2 0 0,-2 0 0,1 2 0,-6-4 0,0 2 0,1 0 0,3-1 0,0 3 0,3-1 0,-2 2 0,6-1 0,-2 1 0,6 1 0,-6-1 0,3 3 0,-3-4 0,3 4 0,-2-3 0,-1 1 0,-4-5 0,1 2 0,-5-2 0,2 2 0,-1-1 0,2 2 0,2-1 0,-1 0 0,-1 1 0,-1-2 0,2 1 0,-1 1 0,0 0 0,1 1 0,6 3 0,0-1 0,2 4 0,3-1 0,0-2 0,-3-2 0,-1 2 0,-4-3 0,2 0 0,-4 2 0,5 0 0,-2-1 0,5 4 0,-2 2 0,1-2 0,2 0 0,-5-2 0,2 0 0,-2-4 0,-1 4 0,-1-4 0,1 4 0,1-3 0,3 3 0,-1-1 0,4 2 0,0 3 0,5 0 0,-5 0 0,8 5 0,-5-3 0,6 6 0,-5-7 0,4 6 0,-5-5 0,2 0 0,-6-4 0,-2 2 0,-1-2 0,-2-2 0,0-2 0,1 2 0,2 3 0,1-2 0,2 5 0,-3-5 0,0 3 0,3-1 0,10 6 0,-4-1 0,5 1 0,-7-6 0,-3 0 0,-10-6 0,2-1 0,-6-3 0,1 3 0,-1-1 0,-1-2 0,1 2 0,-2 1 0,3-3 0,-2 3 0,0-1 0,0 0 0,2-2 0,-2 2 0,6 2 0,-1 2 0,2 1 0,-1-3 0,4 3 0,-2-1 0,0 1 0,-4-4 0,-1-2 0,-5 1 0,0-2 0,0-1 0,-1 2 0,1-1 0,-2 2 0,4-1 0,-1 1 0,3 0 0,0-2 0,3 4 0,-1-3 0,2 3 0,0-4 0,2 3 0,-1 0 0,0 2 0,-2-5 0,-2 4 0,-1-2 0,3 2 0,-2-1 0,3 2 0,-1-2 0,0 1 0,-5-1 0,4 0 0,-1 0 0,0 1 0,2-2 0,-3 2 0,4-2 0,-3 1 0,5 3 0,-4-1 0,4 0 0,-1 0 0,6 4 0,-2-2 0,6 2 0,-6 0 0,2 0 0,-5 0 0,2-1 0,-4 0 0,3-2 0,-6 1 0,7 1 0,-2 1 0,6 2 0,4 1 0,2 2 0,6 3 0,-4 0 0,6 4 0,-10-3 0,2 0 0,-4-6 0,-1 2 0,-2-5 0,1 4 0,-3-5 0,2 3 0,-7-5 0,1 1 0,-4 0 0,1-2 0,-1 0 0,3 0 0,-3 1 0,5-2 0,-6 1 0,2 0 0,-2-3 0,2 5 0,2-4 0,0 5 0,6 1 0,1 3 0,4-1 0,-2-1 0,0-1 0,-3 2 0,2-5 0,-8 1 0,1-3 0,-2 1 0,2-1 0,-4 0 0,3 1 0,-1-2 0,1 0 0,-5-2 0,2 2 0,0 0 0,2 0 0,-3-1 0,3 1 0,-1 1 0,-3-1 0,2 0 0,1-2 0,-2 2 0,1-2 0,0 1 0,-1-2 0,0 2 0,2 0 0,-2-2 0,1 2 0,2-1 0,-5 2 0,8-1 0,-4 2 0,6-1 0,-4 2 0,3-2 0,-3-2 0,3 5 0,-2-4 0,3 3 0,-5 1 0,5-3 0,-2 3 0,1-1 0,1 2 0,-1-4 0,-2 2 0,-1-4 0,0 1 0,0 2 0,1-2 0,-2 0 0,0 1 0,-6-2 0,-1 0 0,1-1 0,-2 2 0,0-3 0,1 1 0,2 0 0,5 3 0,-4-1 0,5 0 0,-3-2 0,-1 2 0,1-1 0,1 0 0,-2 0 0,1 0 0,0 2 0,-3-2 0,4 0 0,-3 0 0,2 2 0,-1-1 0,-1 1 0,1-3 0,0 2 0,-3 0 0,3-1 0,-1 1 0,1 0 0,-3-2 0,2 2 0,-2-1 0,3 0 0,-4 0 0,2 1 0,0-2 0,0 1 0,2-1 0,-4 0 0,2 1 0,-2 0 0,0 0 0,0-1 0,0 0 0,0 1 0,2-1 0,-4 2 0,1-3 0,0 0 0,-2 0 0,0 0 0,-1 0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28T14:55:03.769"/>
    </inkml:context>
    <inkml:brush xml:id="br0">
      <inkml:brushProperty name="width" value="0.025" units="cm"/>
      <inkml:brushProperty name="height" value="0.025" units="cm"/>
      <inkml:brushProperty name="color" value="#FFFFFF"/>
    </inkml:brush>
  </inkml:definitions>
  <inkml:trace contextRef="#ctx0" brushRef="#br0">10140 1188 24575,'-7'2'0,"-2"1"0,-5 2 0,-4-1 0,0 3 0,-4 2 0,0 1 0,0-1 0,2-1 0,-3 1 0,3 1 0,-5-1 0,5 2 0,-2-2 0,4 2 0,0-2 0,1 0 0,4-3 0,1-2 0,4 0 0,-2-2 0,6 0 0,-2 0 0,0 1 0,2 0 0,-1-2 0,1 0 0,-1 3 0,-1-2 0,1 0 0,-4 4 0,1-4 0,-2 5 0,2-4 0,2 2 0,0-2 0,0-1 0,-2 4 0,1-2 0,-5 2 0,3 1 0,-1-2 0,2 2 0,2-3 0,-1 0 0,-1-1 0,4-1 0,-3 4 0,2-4 0,0 4 0,-1-4 0,0 4 0,0-1 0,-3 2 0,0-3 0,-2 2 0,2 1 0,-5 0 0,5-2 0,-4 3 0,-2 0 0,3 1 0,-4-1 0,4 0 0,-4 2 0,3-5 0,-1 3 0,4-3 0,0-1 0,2-1 0,0 2 0,2-2 0,-2 2 0,1 1 0,-5 0 0,4 1 0,1 0 0,2-3 0,-2-2 0,3 2 0,-5-1 0,2 0 0,-2 1 0,1 1 0,0 2 0,-1-2 0,3 0 0,-2 3 0,0-1 0,-1 1 0,1-1 0,-4 5 0,-3-2 0,-2 4 0,2 0 0,-2 2 0,0-4 0,1 2 0,2-2 0,-2 0 0,3-4 0,-2 2 0,5-3 0,-4 2 0,5-3 0,1 0 0,0 1 0,-1-4 0,-3 5 0,1-2 0,-6 1 0,6 0 0,-2-1 0,6-3 0,0 0 0,2-1 0,1 0 0,-1-1 0,2-1 0,2 0 0,-3 1 0,2-1 0,1 0 0,-2 2 0,-2-1 0,1 2 0,-4-2 0,-1 0 0,-6 1 0,-4 0 0,-1 2 0,-4-1 0,2 4 0,-2-2 0,2 2 0,5-2 0,2-2 0,3 2 0,0-4 0,-4 2 0,2 2 0,-2-2 0,1 0 0,-1-2 0,4 2 0,-3-2 0,3 2 0,-4-2 0,4 0 0,-2-1 0,3 3 0,0-3 0,2 1 0,0-1 0,1 0 0,0 0 0,1 2 0,-2-2 0,-1 0 0,-3 0 0,-11 1 0,1-1 0,-7 0 0,3 0 0,2 1 0,3 1 0,2 0 0,7-2 0,-4 0 0,2 0 0,-4 0 0,6 0 0,-7 0 0,5 0 0,-9 0 0,-4 0 0,0 0 0,-2-2 0,3 2 0,3 0 0,0 0 0,8 2 0,1-2 0,5 0 0,2 2 0,-2-2 0,4 1 0,-4-1 0,1 1 0,-4-1 0,-3 2 0,-2-1 0,0 2 0,-6-1 0,4 1 0,-8 5 0,2 0 0,0 1 0,4-1 0,5-2 0,1-1 0,5 2 0,2-5 0,0 4 0,1-4 0,-2 2 0,1 2 0,1 0 0,-1-2 0,1 2 0,-2 0 0,4 1 0,-6 1 0,5 1 0,-2-1 0,3 0 0,0-1 0,0 0 0,1-1 0,1 2 0,-1-2 0,1 0 0,-2 0 0,5-1 0,-2-1 0,1-1 0,0-1 0,0 5 0,-4 0 0,2-1 0,-2 4 0,-1-1 0,0 0 0,-1 1 0,0-1 0,0 0 0,6-2 0,-5 1 0,0 0 0,2 0 0,-3 0 0,3-1 0,-1 1 0,1-2 0,-2 2 0,2 0 0,-3 3 0,-1 0 0,-1-1 0,2 0 0,0-2 0,0-3 0,0 0 0,3 1 0,-3-4 0,0 1 0,-1 1 0,1-1 0,-3-1 0,2 2 0,-2-1 0,2-2 0,-5 1 0,1 0 0,-2 0 0,-1-2 0,-1 2 0,-3-2 0,0 3 0,-1 0 0,2-3 0,2 0 0,5 0 0,0 0 0,0 0 0,-6 0 0,1-3 0,-10 2 0,2 1 0,1-2 0,7 2 0,1 0 0,4-1 0,-4 1 0,1-1 0,3 1 0,1-2 0,-1 0 0,-2 0 0,-1 1 0,-4 0 0,3 1 0,0-2 0,3 2 0,-3-1 0,4-2 0,-1 3 0,1-1 0,0 0 0,5 1 0,-4-2 0,3 1 0,-5 0 0,-3-3 0,-5 0 0,2 2 0,-2-2 0,7 3 0,-3 0 0,1-1 0,-1 1 0,5-2 0,2 3 0,2-1 0,3 0 0,-2-1 0,-2-2 0,-6 0 0,1-1 0,-5 1 0,4 1 0,-2-2 0,-2 4 0,-1-2 0,0-1 0,-2 3 0,4-1 0,-6 0 0,6-1 0,-1 3 0,8-1 0,3 1 0,0 0 0,3 0 0,-3 0 0,1 0 0,1 0 0,2 0 0,-2 0 0,2 0 0,-2 0 0,0-2 0,-6 2 0,4-1 0,-2 1 0,-1 0 0,-6 0 0,-2 0 0,-6 0 0,3 0 0,-2 0 0,4 0 0,0 0 0,4 0 0,4 0 0,4 0 0,3 0 0,2 0 0,1 0 0,-2 0 0,-2 0 0,-3 0 0,-4 0 0,-2 0 0,-2 0 0,-6-3 0,0 1 0,-7 0 0,4 1 0,-3-2 0,9 2 0,0 1 0,3 0 0,-1 0 0,6-3 0,-2 3 0,3-1 0,-5 1 0,4 0 0,-7-1 0,-1-1 0,-2 2 0,-8 0 0,6 0 0,-4 0 0,8 0 0,-5 0 0,5 0 0,-5 0 0,6 0 0,-2-1 0,1 0 0,-3 1 0,2-4 0,-9 4 0,6-2 0,-4 1 0,7 1 0,-3 0 0,3-1 0,-2-1 0,2 2 0,3-2 0,0 2 0,2-2 0,-10 1 0,5 0 0,-12-1 0,6 1 0,-1-2 0,8 3 0,1-1 0,9 1 0,-6 0 0,2 0 0,-8-3 0,3 3 0,-2 0 0,5 0 0,0 0 0,2 0 0,-3 0 0,1 0 0,-4 0 0,1 2 0,2-2 0,0 0 0,5 0 0,-2 0 0,4 0 0,-6 0 0,2 0 0,-4 0 0,-1 0 0,-1 0 0,-1 0 0,1 0 0,4 0 0,-3 0 0,4 0 0,-3 1 0,2-1 0,-10 0 0,8 0 0,-8 0 0,5 0 0,-3 0 0,3 0 0,1 1 0,2-1 0,1 3 0,-3-3 0,-3 0 0,-2 0 0,1 0 0,-7 0 0,7 0 0,-1 0 0,4 0 0,-2 0 0,6 0 0,3 0 0,4 0 0,-5 0 0,-1-3 0,-5 3 0,3-1 0,-3 1 0,6 0 0,-3 0 0,-1 0 0,-4 0 0,-1 0 0,0 0 0,-5 0 0,0 0 0,-13-1 0,-2-3 0,-14-2 0,4 0 0,-10 2 0,20 0 0,-4 2 0,15 0 0,-2 2 0,11 0 0,0-2 0,6 2 0,-1-1 0,4 1 0,2 0 0,5 0 0,-1 0 0,1 0 0,-2 0 0,2 0 0,-1 0 0,1 0 0,3 0 0,-7 0 0,6 0 0,-8 0 0,2 0 0,-6 0 0,1 1 0,-3-1 0,1 2 0,-3-2 0,6 0 0,-6 0 0,8 1 0,-4 0 0,5-1 0,-2 0 0,2 0 0,0 0 0,-2 0 0,-4 0 0,-1 0 0,-2 0 0,-6 0 0,8 0 0,-7 0 0,8 0 0,-3 0 0,2 0 0,-4 0 0,5 0 0,-4-1 0,5 0 0,-2-1 0,2 1 0,-3-3 0,2 0 0,-14-1 0,-2-5 0,-9 1 0,3-2 0,-2 1 0,-6-5 0,5 4 0,-8-1 0,11 2 0,2 0 0,11 2 0,4 2 0,5-1 0,-5-2 0,-1-1 0,0-2 0,2 2 0,-2-1 0,6 2 0,-9-2 0,1-1 0,-7-3 0,7 3 0,-1-2 0,8 4 0,0-3 0,3 2 0,-2-1 0,2 2 0,2 2 0,3-2 0,4 5 0,3 0 0,-1-1 0,-2 0 0,2 0 0,-5-3 0,3 1 0,-3-3 0,3 3 0,-1 0 0,5 4 0,-3-1 0,1 1 0,-1-3 0,0-1 0,-3 0 0,3 3 0,-1-2 0,4 2 0,-1 1 0,1-1 0,-2 2 0,4 0 0,-4-1 0,4 2 0,-4-1 0,2-1 0,-1 0 0,0-1 0,-2 1 0,-1-3 0,0-1 0,-3-1 0,1 1 0,0 1 0,1 0 0,1 1 0,0 2 0,0-6 0,0 5 0,-3-6 0,2 5 0,0-2 0,-1 2 0,1 1 0,0-3 0,-1 3 0,-2-5 0,-1 1 0,-4-4 0,5 6 0,-6-5 0,8 7 0,-5-2 0,4 0 0,1 3 0,0-1 0,1 0 0,2 1 0,1-2 0,-4 0 0,1-2 0,-2 0 0,2-2 0,0 5 0,-1-3 0,0 1 0,2 1 0,-4-1 0,4-1 0,-3-1 0,3 2 0,1-1 0,1 4 0,0-3 0,1 5 0,1-5 0,-1 2 0,-3-1 0,2 1 0,-2-3 0,2 3 0,-1-3 0,2 2 0,-2 1 0,0 0 0,-2-3 0,0 1 0,-1-4 0,-2 1 0,4 2 0,-2-3 0,0 2 0,0-5 0,-5 4 0,0-6 0,3 5 0,0-4 0,3 5 0,-4-6 0,1 4 0,-3-4 0,4 5 0,1-1 0,2 3 0,-2-5 0,2 4 0,-2-6 0,-2 2 0,-2-4 0,2 0 0,3 1 0,-2 0 0,5 3 0,-2-2 0,1 4 0,2-4 0,-1 3 0,-2-3 0,3 1 0,-2-1 0,-2-1 0,1-4 0,0 1 0,0-3 0,3 3 0,-1-3 0,4 6 0,-4-3 0,4 3 0,-1-2 0,-2 4 0,2-2 0,-2-2 0,1-2 0,-4-4 0,0 1 0,1 1 0,2 4 0,-1-1 0,4 7 0,-4-4 0,4 5 0,-4-6 0,2 4 0,-2-2 0,2 1 0,-3 0 0,3 3 0,-3-4 0,1 3 0,-4-3 0,1 3 0,0-3 0,1 5 0,4 2 0,0 2 0,1-1 0,0 3 0,-2-2 0,1-1 0,0 1 0,1 2 0,1 0 0,-2 1 0,2 0 0,1 0 0,0 1 0,-1-1 0,0 3 0,2-1 0,0 0 0,0-4 0,-3 2 0,2-2 0,-1-2 0,-3 1 0,4-4 0,-5 3 0,4-2 0,-2 2 0,0-3 0,-2 3 0,1-1 0,1 1 0,0-2 0,1 6 0,3-2 0,-2 3 0,2 0 0,0 1 0,0 0 0,0 1 0,0-2 0,-3 2 0,3-2 0,-1 1 0,1 0 0,0-2 0,0 2 0,0-5 0,0 3 0,0-1 0,0 1 0,-2-2 0,1 0 0,0-1 0,-1-2 0,2 1 0,-2 1 0,2 3 0,-2 3 0,2-3 0,0 2 0,0 1 0,0-2 0,0 2 0,0-2 0,0 2 0,0-2 0,0 2 0,0 0 0,0-3 0,0 2 0,0 0 0,0 0 0,0-2 0,-1 3 0,1 1 0,0 0 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ACFEC-79D6-624C-83BE-951FD68B7FB0}" type="datetimeFigureOut">
              <a:rPr lang="en-US" smtClean="0"/>
              <a:t>9/1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E1DDAC-A3AD-B64B-9C8F-E8D9279EA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273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g10b95f80276_0_4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3" name="Google Shape;223;g10b95f80276_0_4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670669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g10b95f80276_0_4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3" name="Google Shape;223;g10b95f80276_0_4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283851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52641-60AA-EF59-EE93-97AE20E111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D436B9-CC72-8431-1373-6A34271670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E2F45-581A-9AB5-CC7F-D1BA0943E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040C2-9357-7B47-1A5B-860D02954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27EAC8-6BD6-1717-00BF-E7FF66E71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400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33B03-6009-3AFC-3A3F-A63A7EB62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CD9259-4499-7A8D-DECF-EEB3383024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4D5290-3B3A-B109-9AC1-C99B322AC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11E2E2-8EFF-F84F-12CD-0FC8247C8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A17441-E96C-5D0C-2430-BC12A9D59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34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A18B96-7809-3EA8-FA60-18FD83E9F3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9A6738-1316-6C8F-5336-7F0B3EF44C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A94C1-A16C-4C25-8D3F-F8B77F2F2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1E9CA7-3C3F-18BF-6DBC-AAAA000C3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51538F-140D-3735-9064-B1E44B4E4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541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79661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6B1903-5BD6-1112-BB19-1B52E4991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7D1698-75D1-A1BC-8A75-E07A7CD961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AA1E41-3196-A0C5-3438-6FF4492D8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143DD8-623B-1F72-D142-20AB64EFE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AC6AB-4FC4-C6DF-5160-BBB6F924C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101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D70DA-823A-416B-8E46-B39926A7A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D6A405-A1C7-D91A-C727-D92BE2D84D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16AE8B-D27B-41F4-1939-3C60CCC88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FA4BF6-FF50-B422-17E1-28E161F8A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08015-2973-0247-83FE-757500994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0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6D791B-BD74-09EC-DB0D-93E907BE07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42D04D-DF19-00E2-AA95-95A06742CA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1CB959-4CD6-291C-18C5-94D2AA45A2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4FB64C-19F3-A896-7B51-6A1F32981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077D7F-F3AB-8D3F-4C42-7664679B4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FD9BD5-7C4E-E17D-20B2-4B42080E3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140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18813-70AE-D22C-42C4-CB8EA8D022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3E3FDE-8896-CA36-6C44-50034CB84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BF184C-25DF-B475-1FA5-5CB6AC5508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ED11F8-238D-BE19-8E24-4C867DFDDB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12DD53-11CA-EB40-EE71-C48160B55A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3A0232-731F-6F16-EB68-EB6DFCA2B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EF647C-4F93-E448-70C4-DDE654F8A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62DD46-C096-8E09-2362-1029713AA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49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30C946-4FF1-C72A-F201-2DE05B7C3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B8CFAA-A167-6672-3DC3-B85227108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91AAFC-FCDA-ABF9-7591-30EC0D400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38A4F1-7804-865C-9911-AFE2633A7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112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0EF703-3705-1A8B-7FBC-AF53A828F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CCDF14-034C-1EFA-0BF2-A7D246D07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34D53D-3C12-FE4E-4A82-CF870EA9C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162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10AF2-F0DD-F73D-5404-7104B3DCC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56499D-5110-1DE5-BC65-F94FC357BF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A64A78-605E-D294-7E01-547F5BEF3B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40D32E-36A3-B508-F120-AF29B9884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9FE377-EE9A-28DB-B687-2A3ABF6FD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356638-04D5-5BC2-92CA-6F50C813D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859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4E5BF-145A-EBCE-709B-55CE980B37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042FEC-8567-6EF9-CAE8-5516303A36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7B5D8D-58DC-ABAF-257D-D1FFA33923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4BEFB9-709A-EEBE-96AD-41BA32B08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D49332-4BE6-C7ED-7599-0E48A4F37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428419-CC49-033C-FF55-DE5F38217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328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805C6E-FD1B-BC08-B6C7-B319F4CD72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482A0D-7CE1-C57E-C4D3-B3D0334056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EFC382-484D-9A6C-302E-BC9E2ACA9F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9CC82-DC4C-D648-AFAD-D8ECD54FA73A}" type="datetimeFigureOut">
              <a:rPr lang="en-US" smtClean="0"/>
              <a:t>9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93952-476D-0C3F-BB3E-D964B1F93F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2572EE-0830-8B5A-6DBA-CB0DC340F9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B31F7-874D-5743-A210-9AB64C0E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522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gif"/><Relationship Id="rId13" Type="http://schemas.openxmlformats.org/officeDocument/2006/relationships/image" Target="../media/image11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12" Type="http://schemas.openxmlformats.org/officeDocument/2006/relationships/image" Target="../media/image10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emf"/><Relationship Id="rId11" Type="http://schemas.openxmlformats.org/officeDocument/2006/relationships/image" Target="../media/image9.jpeg"/><Relationship Id="rId5" Type="http://schemas.openxmlformats.org/officeDocument/2006/relationships/image" Target="../media/image3.emf"/><Relationship Id="rId15" Type="http://schemas.openxmlformats.org/officeDocument/2006/relationships/image" Target="../media/image13.jpeg"/><Relationship Id="rId10" Type="http://schemas.openxmlformats.org/officeDocument/2006/relationships/image" Target="../media/image8.gif"/><Relationship Id="rId4" Type="http://schemas.openxmlformats.org/officeDocument/2006/relationships/image" Target="../media/image2.emf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2.xml"/><Relationship Id="rId13" Type="http://schemas.openxmlformats.org/officeDocument/2006/relationships/image" Target="../media/image18.png"/><Relationship Id="rId18" Type="http://schemas.openxmlformats.org/officeDocument/2006/relationships/image" Target="NULL"/><Relationship Id="rId3" Type="http://schemas.microsoft.com/office/2007/relationships/media" Target="../media/media2.avi"/><Relationship Id="rId7" Type="http://schemas.openxmlformats.org/officeDocument/2006/relationships/slideLayout" Target="../slideLayouts/slideLayout12.xml"/><Relationship Id="rId12" Type="http://schemas.openxmlformats.org/officeDocument/2006/relationships/image" Target="../media/image17.jpg"/><Relationship Id="rId17" Type="http://schemas.openxmlformats.org/officeDocument/2006/relationships/customXml" Target="../ink/ink2.xml"/><Relationship Id="rId2" Type="http://schemas.openxmlformats.org/officeDocument/2006/relationships/video" Target="../media/media1.avi"/><Relationship Id="rId16" Type="http://schemas.openxmlformats.org/officeDocument/2006/relationships/image" Target="NULL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16.png"/><Relationship Id="rId5" Type="http://schemas.microsoft.com/office/2007/relationships/media" Target="../media/media3.avi"/><Relationship Id="rId15" Type="http://schemas.openxmlformats.org/officeDocument/2006/relationships/customXml" Target="../ink/ink1.xml"/><Relationship Id="rId10" Type="http://schemas.openxmlformats.org/officeDocument/2006/relationships/image" Target="../media/image15.jpg"/><Relationship Id="rId4" Type="http://schemas.openxmlformats.org/officeDocument/2006/relationships/video" Target="../media/media2.avi"/><Relationship Id="rId9" Type="http://schemas.openxmlformats.org/officeDocument/2006/relationships/image" Target="../media/image14.png"/><Relationship Id="rId1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>
            <a:extLst>
              <a:ext uri="{FF2B5EF4-FFF2-40B4-BE49-F238E27FC236}">
                <a16:creationId xmlns:a16="http://schemas.microsoft.com/office/drawing/2014/main" id="{FC9C3593-8EC9-7D40-77C6-34F49A6BA5B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511" t="16838" b="8403"/>
          <a:stretch/>
        </p:blipFill>
        <p:spPr>
          <a:xfrm>
            <a:off x="6986546" y="836157"/>
            <a:ext cx="2196824" cy="225334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05A5714A-2785-00B5-510B-8D2392B02ED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298" t="12798" b="7935"/>
          <a:stretch/>
        </p:blipFill>
        <p:spPr>
          <a:xfrm>
            <a:off x="9944874" y="3863977"/>
            <a:ext cx="2037645" cy="2235495"/>
          </a:xfrm>
          <a:prstGeom prst="rect">
            <a:avLst/>
          </a:prstGeom>
        </p:spPr>
      </p:pic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5196C0D-926C-4475-C6B4-70FE95C4316D}"/>
              </a:ext>
            </a:extLst>
          </p:cNvPr>
          <p:cNvCxnSpPr>
            <a:cxnSpLocks/>
          </p:cNvCxnSpPr>
          <p:nvPr/>
        </p:nvCxnSpPr>
        <p:spPr>
          <a:xfrm>
            <a:off x="10434050" y="706941"/>
            <a:ext cx="500372" cy="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DA697AB4-336C-10A7-DBCE-BA0CFC0033BC}"/>
              </a:ext>
            </a:extLst>
          </p:cNvPr>
          <p:cNvSpPr txBox="1"/>
          <p:nvPr/>
        </p:nvSpPr>
        <p:spPr>
          <a:xfrm>
            <a:off x="10360963" y="313294"/>
            <a:ext cx="705643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C82A217-8B57-3CE0-69B6-2F8FDAFBB479}"/>
              </a:ext>
            </a:extLst>
          </p:cNvPr>
          <p:cNvSpPr txBox="1"/>
          <p:nvPr/>
        </p:nvSpPr>
        <p:spPr>
          <a:xfrm>
            <a:off x="10352682" y="425636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0EF9725-F5EB-3725-BA3A-A0059DCC8111}"/>
              </a:ext>
            </a:extLst>
          </p:cNvPr>
          <p:cNvSpPr txBox="1"/>
          <p:nvPr/>
        </p:nvSpPr>
        <p:spPr>
          <a:xfrm rot="16200000">
            <a:off x="8756596" y="1864246"/>
            <a:ext cx="185551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movement (%)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11F9828-DE70-1E11-29F7-2EAC4F7E7A17}"/>
              </a:ext>
            </a:extLst>
          </p:cNvPr>
          <p:cNvSpPr txBox="1"/>
          <p:nvPr/>
        </p:nvSpPr>
        <p:spPr>
          <a:xfrm>
            <a:off x="9734234" y="1126294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18E0452D-4B9D-8E1D-B3B3-617ADCD9ACB9}"/>
              </a:ext>
            </a:extLst>
          </p:cNvPr>
          <p:cNvSpPr txBox="1"/>
          <p:nvPr/>
        </p:nvSpPr>
        <p:spPr>
          <a:xfrm>
            <a:off x="9733278" y="1695308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E20DACFC-A806-EA81-CD6B-6DE5C78837D1}"/>
              </a:ext>
            </a:extLst>
          </p:cNvPr>
          <p:cNvSpPr txBox="1"/>
          <p:nvPr/>
        </p:nvSpPr>
        <p:spPr>
          <a:xfrm>
            <a:off x="9738380" y="2273420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6AAD1F9-015F-80BE-0B0F-B680C229272E}"/>
              </a:ext>
            </a:extLst>
          </p:cNvPr>
          <p:cNvSpPr txBox="1"/>
          <p:nvPr/>
        </p:nvSpPr>
        <p:spPr>
          <a:xfrm>
            <a:off x="9794564" y="2834656"/>
            <a:ext cx="253596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6290A96-8D99-201D-A419-B891A02075E1}"/>
              </a:ext>
            </a:extLst>
          </p:cNvPr>
          <p:cNvSpPr txBox="1"/>
          <p:nvPr/>
        </p:nvSpPr>
        <p:spPr>
          <a:xfrm rot="16200000">
            <a:off x="5617835" y="4777765"/>
            <a:ext cx="212194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rograde movement (%)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578C4226-C11E-1CE7-CC6A-160088BCF1FE}"/>
              </a:ext>
            </a:extLst>
          </p:cNvPr>
          <p:cNvSpPr txBox="1"/>
          <p:nvPr/>
        </p:nvSpPr>
        <p:spPr>
          <a:xfrm>
            <a:off x="6732913" y="3724101"/>
            <a:ext cx="400108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91ED3660-4C76-EB19-C2CC-F6F34E6ED084}"/>
              </a:ext>
            </a:extLst>
          </p:cNvPr>
          <p:cNvSpPr txBox="1"/>
          <p:nvPr/>
        </p:nvSpPr>
        <p:spPr>
          <a:xfrm>
            <a:off x="6705310" y="4260568"/>
            <a:ext cx="400108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4CE265F-6D5C-5DB8-BFB8-8174EB985EF4}"/>
              </a:ext>
            </a:extLst>
          </p:cNvPr>
          <p:cNvSpPr txBox="1"/>
          <p:nvPr/>
        </p:nvSpPr>
        <p:spPr>
          <a:xfrm>
            <a:off x="6733187" y="4764548"/>
            <a:ext cx="400108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6C26B68-D16F-0FF0-3A65-EAFEF6B6C2DF}"/>
              </a:ext>
            </a:extLst>
          </p:cNvPr>
          <p:cNvSpPr txBox="1"/>
          <p:nvPr/>
        </p:nvSpPr>
        <p:spPr>
          <a:xfrm>
            <a:off x="6732383" y="5288033"/>
            <a:ext cx="400108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4FB548AA-1C75-6C96-9FED-AF09D7A1B064}"/>
              </a:ext>
            </a:extLst>
          </p:cNvPr>
          <p:cNvSpPr txBox="1"/>
          <p:nvPr/>
        </p:nvSpPr>
        <p:spPr>
          <a:xfrm>
            <a:off x="6826789" y="5807243"/>
            <a:ext cx="323165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CF5E058-D637-A8DE-D490-75CE693916F9}"/>
              </a:ext>
            </a:extLst>
          </p:cNvPr>
          <p:cNvSpPr txBox="1"/>
          <p:nvPr/>
        </p:nvSpPr>
        <p:spPr>
          <a:xfrm>
            <a:off x="6412778" y="3197433"/>
            <a:ext cx="383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B8F1AC-6F28-8C09-F499-AE2EC0F41FC2}"/>
              </a:ext>
            </a:extLst>
          </p:cNvPr>
          <p:cNvSpPr txBox="1"/>
          <p:nvPr/>
        </p:nvSpPr>
        <p:spPr>
          <a:xfrm>
            <a:off x="9438386" y="3150649"/>
            <a:ext cx="472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1CD4492-AB27-77A0-BBA6-E53B725DDAC1}"/>
              </a:ext>
            </a:extLst>
          </p:cNvPr>
          <p:cNvSpPr txBox="1"/>
          <p:nvPr/>
        </p:nvSpPr>
        <p:spPr>
          <a:xfrm>
            <a:off x="6412778" y="106118"/>
            <a:ext cx="485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EBBA75-B8F7-F205-A132-BDF193B37BD7}"/>
              </a:ext>
            </a:extLst>
          </p:cNvPr>
          <p:cNvSpPr txBox="1"/>
          <p:nvPr/>
        </p:nvSpPr>
        <p:spPr>
          <a:xfrm>
            <a:off x="2005589" y="103481"/>
            <a:ext cx="383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EE5F135-E488-7CF9-2959-B283D51F45D5}"/>
              </a:ext>
            </a:extLst>
          </p:cNvPr>
          <p:cNvSpPr txBox="1"/>
          <p:nvPr/>
        </p:nvSpPr>
        <p:spPr>
          <a:xfrm rot="16200000">
            <a:off x="8516670" y="4866473"/>
            <a:ext cx="223549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erograde movement (%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AF8F65F-CFDF-AFE8-E57D-2240C61AD7B9}"/>
              </a:ext>
            </a:extLst>
          </p:cNvPr>
          <p:cNvSpPr txBox="1"/>
          <p:nvPr/>
        </p:nvSpPr>
        <p:spPr>
          <a:xfrm>
            <a:off x="10257606" y="3356318"/>
            <a:ext cx="705643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F51A223-C6A4-3864-5750-70A0CE3D440C}"/>
              </a:ext>
            </a:extLst>
          </p:cNvPr>
          <p:cNvSpPr txBox="1"/>
          <p:nvPr/>
        </p:nvSpPr>
        <p:spPr>
          <a:xfrm>
            <a:off x="10364207" y="3438550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673805BD-21B2-DA20-5156-E16846C96508}"/>
              </a:ext>
            </a:extLst>
          </p:cNvPr>
          <p:cNvCxnSpPr>
            <a:cxnSpLocks/>
          </p:cNvCxnSpPr>
          <p:nvPr/>
        </p:nvCxnSpPr>
        <p:spPr>
          <a:xfrm>
            <a:off x="7590877" y="910913"/>
            <a:ext cx="1012959" cy="49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F0874D05-D8D8-809B-7F21-992048AA80BE}"/>
              </a:ext>
            </a:extLst>
          </p:cNvPr>
          <p:cNvSpPr txBox="1"/>
          <p:nvPr/>
        </p:nvSpPr>
        <p:spPr>
          <a:xfrm rot="16200000">
            <a:off x="5729302" y="1908389"/>
            <a:ext cx="1903956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peed (</a:t>
            </a:r>
            <a:r>
              <a:rPr lang="en-US" sz="1200" b="1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sec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822E38B-A851-6032-EAE1-E19ABB5FE1C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949" b="9348"/>
          <a:stretch/>
        </p:blipFill>
        <p:spPr>
          <a:xfrm>
            <a:off x="7008350" y="3693373"/>
            <a:ext cx="2185683" cy="23380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0CADD69-01AA-75A8-5D11-9B5C1518E03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685" t="14539" b="21542"/>
          <a:stretch/>
        </p:blipFill>
        <p:spPr>
          <a:xfrm>
            <a:off x="9990415" y="987266"/>
            <a:ext cx="1766663" cy="2118183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A5F2A72-44AB-DB36-E6E4-997543BC4598}"/>
              </a:ext>
            </a:extLst>
          </p:cNvPr>
          <p:cNvCxnSpPr>
            <a:cxnSpLocks/>
          </p:cNvCxnSpPr>
          <p:nvPr/>
        </p:nvCxnSpPr>
        <p:spPr>
          <a:xfrm>
            <a:off x="10413211" y="921510"/>
            <a:ext cx="1053568" cy="168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AFD7485C-557F-77AF-F6AA-261FAE100405}"/>
              </a:ext>
            </a:extLst>
          </p:cNvPr>
          <p:cNvSpPr txBox="1"/>
          <p:nvPr/>
        </p:nvSpPr>
        <p:spPr>
          <a:xfrm>
            <a:off x="10705743" y="663888"/>
            <a:ext cx="380232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03097E37-A77B-E886-9C86-EAEC40CBE0EF}"/>
              </a:ext>
            </a:extLst>
          </p:cNvPr>
          <p:cNvCxnSpPr>
            <a:cxnSpLocks/>
          </p:cNvCxnSpPr>
          <p:nvPr/>
        </p:nvCxnSpPr>
        <p:spPr>
          <a:xfrm>
            <a:off x="7389701" y="3701931"/>
            <a:ext cx="511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E53348A4-F804-4C6A-B1CB-926E15D7B7D5}"/>
              </a:ext>
            </a:extLst>
          </p:cNvPr>
          <p:cNvSpPr txBox="1"/>
          <p:nvPr/>
        </p:nvSpPr>
        <p:spPr>
          <a:xfrm>
            <a:off x="7320853" y="3409887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CE5B996-517F-F317-8A54-A8582BFE92E9}"/>
              </a:ext>
            </a:extLst>
          </p:cNvPr>
          <p:cNvSpPr txBox="1"/>
          <p:nvPr/>
        </p:nvSpPr>
        <p:spPr>
          <a:xfrm>
            <a:off x="7279798" y="3323919"/>
            <a:ext cx="705643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9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5F0A36A2-139F-0A80-7E7B-F5BF4996685C}"/>
              </a:ext>
            </a:extLst>
          </p:cNvPr>
          <p:cNvCxnSpPr>
            <a:cxnSpLocks/>
          </p:cNvCxnSpPr>
          <p:nvPr/>
        </p:nvCxnSpPr>
        <p:spPr>
          <a:xfrm>
            <a:off x="7388766" y="3916861"/>
            <a:ext cx="102963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B4BD3A1-6BD0-23EE-B715-D97BD6E501E6}"/>
              </a:ext>
            </a:extLst>
          </p:cNvPr>
          <p:cNvSpPr txBox="1"/>
          <p:nvPr/>
        </p:nvSpPr>
        <p:spPr>
          <a:xfrm>
            <a:off x="7684733" y="3658793"/>
            <a:ext cx="380232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0E0C8A3-A13D-2243-C238-63854715D681}"/>
              </a:ext>
            </a:extLst>
          </p:cNvPr>
          <p:cNvSpPr txBox="1"/>
          <p:nvPr/>
        </p:nvSpPr>
        <p:spPr>
          <a:xfrm>
            <a:off x="9657466" y="4000125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C372FB7-8B10-BC52-4428-3F8AE257D023}"/>
              </a:ext>
            </a:extLst>
          </p:cNvPr>
          <p:cNvSpPr txBox="1"/>
          <p:nvPr/>
        </p:nvSpPr>
        <p:spPr>
          <a:xfrm>
            <a:off x="9653887" y="4446505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FEA42D1-964A-2064-6B00-0AF2841F0438}"/>
              </a:ext>
            </a:extLst>
          </p:cNvPr>
          <p:cNvSpPr txBox="1"/>
          <p:nvPr/>
        </p:nvSpPr>
        <p:spPr>
          <a:xfrm>
            <a:off x="9649380" y="4895397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11B4B38-891E-5335-2995-B61D8B9F39F5}"/>
              </a:ext>
            </a:extLst>
          </p:cNvPr>
          <p:cNvSpPr txBox="1"/>
          <p:nvPr/>
        </p:nvSpPr>
        <p:spPr>
          <a:xfrm>
            <a:off x="9648576" y="5358824"/>
            <a:ext cx="322524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4003C96-8D22-4ED1-7F95-59BAA91AA3A4}"/>
              </a:ext>
            </a:extLst>
          </p:cNvPr>
          <p:cNvSpPr txBox="1"/>
          <p:nvPr/>
        </p:nvSpPr>
        <p:spPr>
          <a:xfrm>
            <a:off x="9742982" y="5799959"/>
            <a:ext cx="253596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AE3D455-67AA-99B8-7331-6CCC2A94BCC5}"/>
              </a:ext>
            </a:extLst>
          </p:cNvPr>
          <p:cNvCxnSpPr>
            <a:cxnSpLocks/>
          </p:cNvCxnSpPr>
          <p:nvPr/>
        </p:nvCxnSpPr>
        <p:spPr>
          <a:xfrm>
            <a:off x="10356231" y="3724101"/>
            <a:ext cx="511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F1910FD7-A23C-99B9-2264-6936E0C3D52D}"/>
              </a:ext>
            </a:extLst>
          </p:cNvPr>
          <p:cNvCxnSpPr>
            <a:cxnSpLocks/>
          </p:cNvCxnSpPr>
          <p:nvPr/>
        </p:nvCxnSpPr>
        <p:spPr>
          <a:xfrm>
            <a:off x="10352682" y="3936453"/>
            <a:ext cx="102963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017F1C4F-D049-8BF3-D78F-7EA0E8B20CD8}"/>
              </a:ext>
            </a:extLst>
          </p:cNvPr>
          <p:cNvSpPr txBox="1"/>
          <p:nvPr/>
        </p:nvSpPr>
        <p:spPr>
          <a:xfrm>
            <a:off x="10633247" y="3687083"/>
            <a:ext cx="380232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33F12FC-77BE-8180-E4A5-923080D173F0}"/>
              </a:ext>
            </a:extLst>
          </p:cNvPr>
          <p:cNvSpPr txBox="1"/>
          <p:nvPr/>
        </p:nvSpPr>
        <p:spPr>
          <a:xfrm>
            <a:off x="6677671" y="1012188"/>
            <a:ext cx="438581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5E18151-70AB-C159-D5EC-E708BFB53AA0}"/>
              </a:ext>
            </a:extLst>
          </p:cNvPr>
          <p:cNvSpPr txBox="1"/>
          <p:nvPr/>
        </p:nvSpPr>
        <p:spPr>
          <a:xfrm>
            <a:off x="6675569" y="1619613"/>
            <a:ext cx="438581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EAF41C4-F31A-385B-51AF-B0E691C5C4C6}"/>
              </a:ext>
            </a:extLst>
          </p:cNvPr>
          <p:cNvSpPr txBox="1"/>
          <p:nvPr/>
        </p:nvSpPr>
        <p:spPr>
          <a:xfrm>
            <a:off x="6676125" y="2221332"/>
            <a:ext cx="438581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C5542DE-15C7-4206-93BD-8A5AF1EF1EC4}"/>
              </a:ext>
            </a:extLst>
          </p:cNvPr>
          <p:cNvSpPr txBox="1"/>
          <p:nvPr/>
        </p:nvSpPr>
        <p:spPr>
          <a:xfrm>
            <a:off x="6798367" y="2824605"/>
            <a:ext cx="323165" cy="256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3FA86AA3-496A-5F1F-FB45-0516250C7623}"/>
              </a:ext>
            </a:extLst>
          </p:cNvPr>
          <p:cNvCxnSpPr>
            <a:cxnSpLocks/>
          </p:cNvCxnSpPr>
          <p:nvPr/>
        </p:nvCxnSpPr>
        <p:spPr>
          <a:xfrm>
            <a:off x="7590557" y="709070"/>
            <a:ext cx="500372" cy="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65E920A9-32DB-C7CB-95CF-FD2A00BB0172}"/>
              </a:ext>
            </a:extLst>
          </p:cNvPr>
          <p:cNvSpPr txBox="1"/>
          <p:nvPr/>
        </p:nvSpPr>
        <p:spPr>
          <a:xfrm>
            <a:off x="7506079" y="313294"/>
            <a:ext cx="705643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823DCD8-A7CE-51BB-D921-98586F6E66D8}"/>
              </a:ext>
            </a:extLst>
          </p:cNvPr>
          <p:cNvSpPr txBox="1"/>
          <p:nvPr/>
        </p:nvSpPr>
        <p:spPr>
          <a:xfrm>
            <a:off x="7520896" y="426339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BCE96FC-702E-0F88-113B-6D1FB0E331AC}"/>
              </a:ext>
            </a:extLst>
          </p:cNvPr>
          <p:cNvSpPr txBox="1"/>
          <p:nvPr/>
        </p:nvSpPr>
        <p:spPr>
          <a:xfrm>
            <a:off x="7839715" y="663888"/>
            <a:ext cx="380232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76" name="Picture 75" descr="A close-up of a crack&#10;&#10;Description automatically generated">
            <a:extLst>
              <a:ext uri="{FF2B5EF4-FFF2-40B4-BE49-F238E27FC236}">
                <a16:creationId xmlns:a16="http://schemas.microsoft.com/office/drawing/2014/main" id="{788A8155-EEEA-2A8C-87C9-AD15794F948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10752" y="4582992"/>
            <a:ext cx="3249318" cy="11463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097DC7DD-8044-F1EB-ED2B-326844B5413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15388" y="5777415"/>
            <a:ext cx="3257702" cy="201293"/>
          </a:xfrm>
          <a:prstGeom prst="rect">
            <a:avLst/>
          </a:prstGeom>
        </p:spPr>
      </p:pic>
      <p:pic>
        <p:nvPicPr>
          <p:cNvPr id="93" name="Picture 92" descr="A close-up of a forest&#10;&#10;Description automatically generated">
            <a:extLst>
              <a:ext uri="{FF2B5EF4-FFF2-40B4-BE49-F238E27FC236}">
                <a16:creationId xmlns:a16="http://schemas.microsoft.com/office/drawing/2014/main" id="{E750A8CB-7D0B-F32B-120B-8EFD06E8119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07184" y="2507361"/>
            <a:ext cx="3265906" cy="12205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DC1D81CF-9081-4976-8FEE-1F1D154B465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10764" y="3773352"/>
            <a:ext cx="3249306" cy="188493"/>
          </a:xfrm>
          <a:prstGeom prst="rect">
            <a:avLst/>
          </a:prstGeom>
        </p:spPr>
      </p:pic>
      <p:pic>
        <p:nvPicPr>
          <p:cNvPr id="98" name="Picture 97" descr="A black and white image of a tree&#10;&#10;Description automatically generated">
            <a:extLst>
              <a:ext uri="{FF2B5EF4-FFF2-40B4-BE49-F238E27FC236}">
                <a16:creationId xmlns:a16="http://schemas.microsoft.com/office/drawing/2014/main" id="{79B2E046-E502-10A4-D659-DC679C131E2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20197" y="539371"/>
            <a:ext cx="3313573" cy="12281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621D359F-463D-303B-1300-C76112E983D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18776" y="1823697"/>
            <a:ext cx="3303764" cy="159724"/>
          </a:xfrm>
          <a:prstGeom prst="rect">
            <a:avLst/>
          </a:prstGeom>
        </p:spPr>
      </p:pic>
      <p:pic>
        <p:nvPicPr>
          <p:cNvPr id="109" name="Picture 108">
            <a:extLst>
              <a:ext uri="{FF2B5EF4-FFF2-40B4-BE49-F238E27FC236}">
                <a16:creationId xmlns:a16="http://schemas.microsoft.com/office/drawing/2014/main" id="{0E9EB6DB-2AFC-4552-A584-EC755D09347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500557" y="2015372"/>
            <a:ext cx="3321982" cy="160605"/>
          </a:xfrm>
          <a:prstGeom prst="rect">
            <a:avLst/>
          </a:prstGeom>
        </p:spPr>
      </p:pic>
      <p:pic>
        <p:nvPicPr>
          <p:cNvPr id="132" name="Picture 131">
            <a:extLst>
              <a:ext uri="{FF2B5EF4-FFF2-40B4-BE49-F238E27FC236}">
                <a16:creationId xmlns:a16="http://schemas.microsoft.com/office/drawing/2014/main" id="{3FEACB3F-7CCE-CBB6-9065-6ECB62F3312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06524" y="6004321"/>
            <a:ext cx="3270357" cy="202075"/>
          </a:xfrm>
          <a:prstGeom prst="rect">
            <a:avLst/>
          </a:prstGeom>
        </p:spPr>
      </p:pic>
      <p:pic>
        <p:nvPicPr>
          <p:cNvPr id="134" name="Picture 133">
            <a:extLst>
              <a:ext uri="{FF2B5EF4-FFF2-40B4-BE49-F238E27FC236}">
                <a16:creationId xmlns:a16="http://schemas.microsoft.com/office/drawing/2014/main" id="{9C4F056C-FD3D-4898-0E85-75D2C39F0C1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94169" y="3995421"/>
            <a:ext cx="3265901" cy="189456"/>
          </a:xfrm>
          <a:prstGeom prst="rect">
            <a:avLst/>
          </a:prstGeom>
        </p:spPr>
      </p:pic>
      <p:sp>
        <p:nvSpPr>
          <p:cNvPr id="136" name="TextBox 135">
            <a:extLst>
              <a:ext uri="{FF2B5EF4-FFF2-40B4-BE49-F238E27FC236}">
                <a16:creationId xmlns:a16="http://schemas.microsoft.com/office/drawing/2014/main" id="{41FB70CA-46D1-4B2F-EDA8-51C2B421CB1D}"/>
              </a:ext>
            </a:extLst>
          </p:cNvPr>
          <p:cNvSpPr txBox="1"/>
          <p:nvPr/>
        </p:nvSpPr>
        <p:spPr>
          <a:xfrm>
            <a:off x="4989311" y="1544473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-RFP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D909FCE6-8F6F-DBFC-18F0-670550AE6953}"/>
              </a:ext>
            </a:extLst>
          </p:cNvPr>
          <p:cNvSpPr txBox="1"/>
          <p:nvPr/>
        </p:nvSpPr>
        <p:spPr>
          <a:xfrm>
            <a:off x="4966551" y="3472146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1X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7C574A2-0234-D826-BDB4-21DE46965317}"/>
              </a:ext>
            </a:extLst>
          </p:cNvPr>
          <p:cNvSpPr txBox="1"/>
          <p:nvPr/>
        </p:nvSpPr>
        <p:spPr>
          <a:xfrm>
            <a:off x="4969955" y="5459441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9X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9C61FFD2-91AF-C54B-0C04-F06933A0404D}"/>
              </a:ext>
            </a:extLst>
          </p:cNvPr>
          <p:cNvSpPr txBox="1"/>
          <p:nvPr/>
        </p:nvSpPr>
        <p:spPr>
          <a:xfrm rot="5400000">
            <a:off x="6975198" y="6241343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-RFP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4D8901EA-61B0-E735-691D-0234618DAD1F}"/>
              </a:ext>
            </a:extLst>
          </p:cNvPr>
          <p:cNvSpPr txBox="1"/>
          <p:nvPr/>
        </p:nvSpPr>
        <p:spPr>
          <a:xfrm rot="5400000">
            <a:off x="7469599" y="6194935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1X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0131E4D-AA96-CC10-5678-4CE564D12546}"/>
              </a:ext>
            </a:extLst>
          </p:cNvPr>
          <p:cNvSpPr txBox="1"/>
          <p:nvPr/>
        </p:nvSpPr>
        <p:spPr>
          <a:xfrm rot="5400000">
            <a:off x="7962851" y="6194935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9X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C9BCC462-5F50-4168-7357-00DAC2F43852}"/>
              </a:ext>
            </a:extLst>
          </p:cNvPr>
          <p:cNvSpPr txBox="1"/>
          <p:nvPr/>
        </p:nvSpPr>
        <p:spPr>
          <a:xfrm rot="5400000">
            <a:off x="9897363" y="6242641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-RFP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BA52A8D-E198-5632-E45B-BA357BCF96E8}"/>
              </a:ext>
            </a:extLst>
          </p:cNvPr>
          <p:cNvSpPr txBox="1"/>
          <p:nvPr/>
        </p:nvSpPr>
        <p:spPr>
          <a:xfrm rot="5400000">
            <a:off x="10361738" y="6196233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1X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2AFF006A-C691-34C0-D33C-7FE5C41074BE}"/>
              </a:ext>
            </a:extLst>
          </p:cNvPr>
          <p:cNvSpPr txBox="1"/>
          <p:nvPr/>
        </p:nvSpPr>
        <p:spPr>
          <a:xfrm rot="5400000">
            <a:off x="10806946" y="6196233"/>
            <a:ext cx="92294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9X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359A56E1-03EE-5974-4011-DD0068AEBCD3}"/>
              </a:ext>
            </a:extLst>
          </p:cNvPr>
          <p:cNvSpPr txBox="1"/>
          <p:nvPr/>
        </p:nvSpPr>
        <p:spPr>
          <a:xfrm>
            <a:off x="9635858" y="103481"/>
            <a:ext cx="485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9818D645-2130-68CC-9389-93472EC2092A}"/>
              </a:ext>
            </a:extLst>
          </p:cNvPr>
          <p:cNvSpPr txBox="1"/>
          <p:nvPr/>
        </p:nvSpPr>
        <p:spPr>
          <a:xfrm rot="16200000">
            <a:off x="1966509" y="968616"/>
            <a:ext cx="720607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 sec</a:t>
            </a: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793E928A-DE20-0E62-C0D8-93AC7892D6AC}"/>
              </a:ext>
            </a:extLst>
          </p:cNvPr>
          <p:cNvCxnSpPr>
            <a:cxnSpLocks/>
          </p:cNvCxnSpPr>
          <p:nvPr/>
        </p:nvCxnSpPr>
        <p:spPr>
          <a:xfrm flipV="1">
            <a:off x="2453941" y="568734"/>
            <a:ext cx="0" cy="11709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8" name="TextBox 147">
            <a:extLst>
              <a:ext uri="{FF2B5EF4-FFF2-40B4-BE49-F238E27FC236}">
                <a16:creationId xmlns:a16="http://schemas.microsoft.com/office/drawing/2014/main" id="{1A6E5C95-1FDD-7F0E-36F1-3676A668E0D5}"/>
              </a:ext>
            </a:extLst>
          </p:cNvPr>
          <p:cNvSpPr txBox="1"/>
          <p:nvPr/>
        </p:nvSpPr>
        <p:spPr>
          <a:xfrm rot="16200000">
            <a:off x="1929604" y="2869545"/>
            <a:ext cx="721495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 sec</a:t>
            </a: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F0831D78-E9B0-A612-6201-E0380C28B4EE}"/>
              </a:ext>
            </a:extLst>
          </p:cNvPr>
          <p:cNvCxnSpPr>
            <a:cxnSpLocks/>
          </p:cNvCxnSpPr>
          <p:nvPr/>
        </p:nvCxnSpPr>
        <p:spPr>
          <a:xfrm flipV="1">
            <a:off x="2451677" y="2507361"/>
            <a:ext cx="0" cy="11709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E531974E-48A9-2F4C-273E-7EF9219E8729}"/>
              </a:ext>
            </a:extLst>
          </p:cNvPr>
          <p:cNvSpPr txBox="1"/>
          <p:nvPr/>
        </p:nvSpPr>
        <p:spPr>
          <a:xfrm rot="16200000">
            <a:off x="1966064" y="5002263"/>
            <a:ext cx="721496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 sec</a:t>
            </a: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A45B4900-463D-7F17-ECEA-75B71E329511}"/>
              </a:ext>
            </a:extLst>
          </p:cNvPr>
          <p:cNvCxnSpPr>
            <a:cxnSpLocks/>
          </p:cNvCxnSpPr>
          <p:nvPr/>
        </p:nvCxnSpPr>
        <p:spPr>
          <a:xfrm flipV="1">
            <a:off x="2452326" y="4570653"/>
            <a:ext cx="0" cy="11709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8F6ED5F-0D69-F0A3-9579-F302ECC745DC}"/>
              </a:ext>
            </a:extLst>
          </p:cNvPr>
          <p:cNvCxnSpPr/>
          <p:nvPr/>
        </p:nvCxnSpPr>
        <p:spPr>
          <a:xfrm>
            <a:off x="2520096" y="482776"/>
            <a:ext cx="330244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420C8C1D-3043-2684-9F26-833360676AC6}"/>
              </a:ext>
            </a:extLst>
          </p:cNvPr>
          <p:cNvSpPr txBox="1"/>
          <p:nvPr/>
        </p:nvSpPr>
        <p:spPr>
          <a:xfrm>
            <a:off x="3582625" y="220684"/>
            <a:ext cx="1157844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21920" tIns="60960" rIns="121920" bIns="6096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erograde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5CC727C-AD1C-00BD-B016-29719B1885D0}"/>
              </a:ext>
            </a:extLst>
          </p:cNvPr>
          <p:cNvCxnSpPr>
            <a:cxnSpLocks/>
          </p:cNvCxnSpPr>
          <p:nvPr/>
        </p:nvCxnSpPr>
        <p:spPr>
          <a:xfrm flipH="1">
            <a:off x="2507184" y="6274678"/>
            <a:ext cx="32931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5F156E01-82A1-CA78-487A-0B55935B2758}"/>
              </a:ext>
            </a:extLst>
          </p:cNvPr>
          <p:cNvSpPr txBox="1"/>
          <p:nvPr/>
        </p:nvSpPr>
        <p:spPr>
          <a:xfrm>
            <a:off x="2274694" y="1949422"/>
            <a:ext cx="277640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067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6CAE6E-1289-0062-57A5-433DB4E400C6}"/>
              </a:ext>
            </a:extLst>
          </p:cNvPr>
          <p:cNvSpPr txBox="1"/>
          <p:nvPr/>
        </p:nvSpPr>
        <p:spPr>
          <a:xfrm>
            <a:off x="2245652" y="3927780"/>
            <a:ext cx="277640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067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964D75-F7C8-92D7-D223-408B7AA0A4A0}"/>
              </a:ext>
            </a:extLst>
          </p:cNvPr>
          <p:cNvSpPr txBox="1"/>
          <p:nvPr/>
        </p:nvSpPr>
        <p:spPr>
          <a:xfrm>
            <a:off x="2258073" y="5954063"/>
            <a:ext cx="277640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067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5488ECE-339A-9DAA-3942-9B9FD9FD191B}"/>
              </a:ext>
            </a:extLst>
          </p:cNvPr>
          <p:cNvSpPr/>
          <p:nvPr/>
        </p:nvSpPr>
        <p:spPr>
          <a:xfrm>
            <a:off x="2084204" y="185130"/>
            <a:ext cx="9751489" cy="65935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6DB248-7696-7362-DB76-94FFD62F5165}"/>
              </a:ext>
            </a:extLst>
          </p:cNvPr>
          <p:cNvSpPr txBox="1"/>
          <p:nvPr/>
        </p:nvSpPr>
        <p:spPr>
          <a:xfrm>
            <a:off x="3798343" y="6240779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sz="11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5" name="Subtitle 2">
            <a:extLst>
              <a:ext uri="{FF2B5EF4-FFF2-40B4-BE49-F238E27FC236}">
                <a16:creationId xmlns:a16="http://schemas.microsoft.com/office/drawing/2014/main" id="{4C234E8A-E793-88D6-5B1E-9529D028ADEC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913327" cy="28994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kern="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6 (live):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077278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REN MAM9X (6days).4a.nd2 - Z=0 C=0">
            <a:hlinkClick r:id="" action="ppaction://media"/>
            <a:extLst>
              <a:ext uri="{FF2B5EF4-FFF2-40B4-BE49-F238E27FC236}">
                <a16:creationId xmlns:a16="http://schemas.microsoft.com/office/drawing/2014/main" id="{125F1DE4-B065-8927-6310-150C29DAC98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970672" y="3809473"/>
            <a:ext cx="5086059" cy="127151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2B4693-C07D-453F-A15B-E27B7BC1E4A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70198" y="5188824"/>
            <a:ext cx="5066864" cy="1266716"/>
          </a:xfrm>
          <a:prstGeom prst="rect">
            <a:avLst/>
          </a:prstGeom>
        </p:spPr>
      </p:pic>
      <p:pic>
        <p:nvPicPr>
          <p:cNvPr id="9" name="REN MAM9X (6days).7a.nd2 - Z=0 C=0">
            <a:hlinkClick r:id="" action="ppaction://media"/>
            <a:extLst>
              <a:ext uri="{FF2B5EF4-FFF2-40B4-BE49-F238E27FC236}">
                <a16:creationId xmlns:a16="http://schemas.microsoft.com/office/drawing/2014/main" id="{56BFBBB2-72F0-36A5-622E-FD0B3F19979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6142007" y="3814169"/>
            <a:ext cx="5067275" cy="126681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8AAA601-B097-9D38-6CB1-1C8941AC7B5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142007" y="5193519"/>
            <a:ext cx="5066864" cy="1266716"/>
          </a:xfrm>
          <a:prstGeom prst="rect">
            <a:avLst/>
          </a:prstGeom>
        </p:spPr>
      </p:pic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1A6E794-8FDD-3314-F341-60EAD2864627}"/>
              </a:ext>
            </a:extLst>
          </p:cNvPr>
          <p:cNvCxnSpPr/>
          <p:nvPr/>
        </p:nvCxnSpPr>
        <p:spPr>
          <a:xfrm>
            <a:off x="2983993" y="6455542"/>
            <a:ext cx="219266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B284B2E-1B06-1917-4FE9-93F4C0F5E2C0}"/>
              </a:ext>
            </a:extLst>
          </p:cNvPr>
          <p:cNvSpPr txBox="1"/>
          <p:nvPr/>
        </p:nvSpPr>
        <p:spPr>
          <a:xfrm rot="16200000">
            <a:off x="-99953" y="4787499"/>
            <a:ext cx="1602362" cy="369332"/>
          </a:xfrm>
          <a:prstGeom prst="rect">
            <a:avLst/>
          </a:prstGeom>
          <a:noFill/>
        </p:spPr>
        <p:txBody>
          <a:bodyPr wrap="none" lIns="121920" tIns="60960" rIns="121920" bIns="60960" rtlCol="0" anchor="t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9X +GFP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66FC3585-CB41-D75C-A55E-2E0BA69D6365}"/>
              </a:ext>
            </a:extLst>
          </p:cNvPr>
          <p:cNvCxnSpPr>
            <a:cxnSpLocks/>
          </p:cNvCxnSpPr>
          <p:nvPr/>
        </p:nvCxnSpPr>
        <p:spPr>
          <a:xfrm>
            <a:off x="1912717" y="6235488"/>
            <a:ext cx="3360145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70DDEC13-708A-7F69-B1F1-DDE05ACAD2F6}"/>
              </a:ext>
            </a:extLst>
          </p:cNvPr>
          <p:cNvCxnSpPr>
            <a:cxnSpLocks/>
          </p:cNvCxnSpPr>
          <p:nvPr/>
        </p:nvCxnSpPr>
        <p:spPr>
          <a:xfrm flipV="1">
            <a:off x="7002407" y="5556003"/>
            <a:ext cx="3327197" cy="619686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REN MAM1X (6days).5b.nd2 - Z=0 C=0">
            <a:hlinkClick r:id="" action="ppaction://media"/>
            <a:extLst>
              <a:ext uri="{FF2B5EF4-FFF2-40B4-BE49-F238E27FC236}">
                <a16:creationId xmlns:a16="http://schemas.microsoft.com/office/drawing/2014/main" id="{6C18647A-10AF-3C9F-9A8B-033F3E8E266B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958323" y="937608"/>
            <a:ext cx="5067275" cy="126681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9AFB8F0-7361-2BD7-9189-0B6DFC513F3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57849" y="2322603"/>
            <a:ext cx="5067275" cy="1266819"/>
          </a:xfrm>
          <a:prstGeom prst="rect">
            <a:avLst/>
          </a:prstGeom>
        </p:spPr>
      </p:pic>
      <p:pic>
        <p:nvPicPr>
          <p:cNvPr id="5" name="REN MAM1X (6days).5b.nd2 - Z=0 C=0">
            <a:hlinkClick r:id="" action="ppaction://media"/>
            <a:extLst>
              <a:ext uri="{FF2B5EF4-FFF2-40B4-BE49-F238E27FC236}">
                <a16:creationId xmlns:a16="http://schemas.microsoft.com/office/drawing/2014/main" id="{942283F6-717C-4168-669E-C5C5714F67A1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6142007" y="939726"/>
            <a:ext cx="5067269" cy="126681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13CD523-8F87-CCC2-FE6F-2D8CCC53917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41528" y="2308617"/>
            <a:ext cx="5067275" cy="1266819"/>
          </a:xfrm>
          <a:prstGeom prst="rect">
            <a:avLst/>
          </a:prstGeom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15">
            <p14:nvContentPartPr>
              <p14:cNvPr id="21" name="Ink 20">
                <a:extLst>
                  <a:ext uri="{FF2B5EF4-FFF2-40B4-BE49-F238E27FC236}">
                    <a16:creationId xmlns:a16="http://schemas.microsoft.com/office/drawing/2014/main" id="{37C81438-F67D-1084-62FB-5A69B9CDE7BD}"/>
                  </a:ext>
                </a:extLst>
              </p14:cNvPr>
              <p14:cNvContentPartPr/>
              <p14:nvPr/>
            </p14:nvContentPartPr>
            <p14:xfrm>
              <a:off x="1635293" y="2481993"/>
              <a:ext cx="4146980" cy="676676"/>
            </p14:xfrm>
          </p:contentPart>
        </mc:Choice>
        <mc:Fallback xmlns="">
          <p:pic>
            <p:nvPicPr>
              <p:cNvPr id="21" name="Ink 20">
                <a:extLst>
                  <a:ext uri="{FF2B5EF4-FFF2-40B4-BE49-F238E27FC236}">
                    <a16:creationId xmlns:a16="http://schemas.microsoft.com/office/drawing/2014/main" id="{37C81438-F67D-1084-62FB-5A69B9CDE7BD}"/>
                  </a:ext>
                </a:extLst>
              </p:cNvPr>
              <p:cNvPicPr/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630972" y="2477674"/>
                <a:ext cx="4155621" cy="68531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7">
            <p14:nvContentPartPr>
              <p14:cNvPr id="22" name="Ink 21">
                <a:extLst>
                  <a:ext uri="{FF2B5EF4-FFF2-40B4-BE49-F238E27FC236}">
                    <a16:creationId xmlns:a16="http://schemas.microsoft.com/office/drawing/2014/main" id="{91978438-478A-43C8-9CB1-C9E9A7C23927}"/>
                  </a:ext>
                </a:extLst>
              </p14:cNvPr>
              <p14:cNvContentPartPr/>
              <p14:nvPr/>
            </p14:nvContentPartPr>
            <p14:xfrm>
              <a:off x="6861507" y="2396370"/>
              <a:ext cx="3650711" cy="882596"/>
            </p14:xfrm>
          </p:contentPart>
        </mc:Choice>
        <mc:Fallback xmlns="">
          <p:pic>
            <p:nvPicPr>
              <p:cNvPr id="22" name="Ink 21">
                <a:extLst>
                  <a:ext uri="{FF2B5EF4-FFF2-40B4-BE49-F238E27FC236}">
                    <a16:creationId xmlns:a16="http://schemas.microsoft.com/office/drawing/2014/main" id="{91978438-478A-43C8-9CB1-C9E9A7C23927}"/>
                  </a:ext>
                </a:extLst>
              </p:cNvPr>
              <p:cNvPicPr/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6857187" y="2392051"/>
                <a:ext cx="3659352" cy="891235"/>
              </a:xfrm>
              <a:prstGeom prst="rect">
                <a:avLst/>
              </a:prstGeom>
            </p:spPr>
          </p:pic>
        </mc:Fallback>
      </mc:AlternateContent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579FB9D5-1A16-C172-5FCF-C6F3C2939046}"/>
              </a:ext>
            </a:extLst>
          </p:cNvPr>
          <p:cNvCxnSpPr>
            <a:cxnSpLocks/>
          </p:cNvCxnSpPr>
          <p:nvPr/>
        </p:nvCxnSpPr>
        <p:spPr>
          <a:xfrm flipH="1">
            <a:off x="1555522" y="2577689"/>
            <a:ext cx="87971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0A7F7A3-0B50-BB05-207E-AA5539F4B5A4}"/>
              </a:ext>
            </a:extLst>
          </p:cNvPr>
          <p:cNvCxnSpPr>
            <a:cxnSpLocks/>
          </p:cNvCxnSpPr>
          <p:nvPr/>
        </p:nvCxnSpPr>
        <p:spPr>
          <a:xfrm flipV="1">
            <a:off x="10507618" y="2779102"/>
            <a:ext cx="69397" cy="4832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0C4A9C27-9962-44C4-1501-871A5276242D}"/>
              </a:ext>
            </a:extLst>
          </p:cNvPr>
          <p:cNvCxnSpPr>
            <a:cxnSpLocks/>
          </p:cNvCxnSpPr>
          <p:nvPr/>
        </p:nvCxnSpPr>
        <p:spPr>
          <a:xfrm>
            <a:off x="8681675" y="3480337"/>
            <a:ext cx="243899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49F62217-F8D9-71B9-9212-6253DD8F3ACE}"/>
              </a:ext>
            </a:extLst>
          </p:cNvPr>
          <p:cNvSpPr txBox="1"/>
          <p:nvPr/>
        </p:nvSpPr>
        <p:spPr>
          <a:xfrm rot="16200000">
            <a:off x="-147433" y="2123951"/>
            <a:ext cx="1697324" cy="369332"/>
          </a:xfrm>
          <a:prstGeom prst="rect">
            <a:avLst/>
          </a:prstGeom>
          <a:noFill/>
        </p:spPr>
        <p:txBody>
          <a:bodyPr wrap="none" lIns="121920" tIns="60960" rIns="121920" bIns="60960" rtlCol="0" anchor="t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 1X + GFP 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6AF0708-4F42-0C15-2E04-D20936639BA8}"/>
              </a:ext>
            </a:extLst>
          </p:cNvPr>
          <p:cNvSpPr txBox="1"/>
          <p:nvPr/>
        </p:nvSpPr>
        <p:spPr>
          <a:xfrm>
            <a:off x="1028558" y="3823058"/>
            <a:ext cx="1060547" cy="369332"/>
          </a:xfrm>
          <a:prstGeom prst="rect">
            <a:avLst/>
          </a:prstGeom>
          <a:noFill/>
        </p:spPr>
        <p:txBody>
          <a:bodyPr wrap="none" lIns="121920" tIns="60960" rIns="121920" bIns="60960" rtlCol="0" anchor="t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M 9X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65DF5FB-D7A0-8E8C-05B8-27E2BDBD7209}"/>
              </a:ext>
            </a:extLst>
          </p:cNvPr>
          <p:cNvSpPr txBox="1"/>
          <p:nvPr/>
        </p:nvSpPr>
        <p:spPr>
          <a:xfrm>
            <a:off x="925849" y="5203008"/>
            <a:ext cx="1637912" cy="369332"/>
          </a:xfrm>
          <a:prstGeom prst="rect">
            <a:avLst/>
          </a:prstGeom>
          <a:noFill/>
        </p:spPr>
        <p:txBody>
          <a:bodyPr wrap="square" lIns="121920" tIns="60960" rIns="121920" bIns="60960" rtlCol="0" anchor="t">
            <a:spAutoFit/>
          </a:bodyPr>
          <a:lstStyle/>
          <a:p>
            <a:pPr algn="ctr"/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M 9X </a:t>
            </a:r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67E6F8C-77BD-3E9C-CC78-67661D75313D}"/>
              </a:ext>
            </a:extLst>
          </p:cNvPr>
          <p:cNvSpPr txBox="1"/>
          <p:nvPr/>
        </p:nvSpPr>
        <p:spPr>
          <a:xfrm>
            <a:off x="885892" y="2269913"/>
            <a:ext cx="1677869" cy="369332"/>
          </a:xfrm>
          <a:prstGeom prst="rect">
            <a:avLst/>
          </a:prstGeom>
          <a:noFill/>
        </p:spPr>
        <p:txBody>
          <a:bodyPr wrap="square" lIns="121920" tIns="60960" rIns="121920" bIns="60960" rtlCol="0" anchor="t">
            <a:spAutoFit/>
          </a:bodyPr>
          <a:lstStyle/>
          <a:p>
            <a:pPr algn="ctr"/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M 1X </a:t>
            </a:r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245A7A5-9479-8161-7C27-88FDEFEBCC3B}"/>
              </a:ext>
            </a:extLst>
          </p:cNvPr>
          <p:cNvSpPr txBox="1"/>
          <p:nvPr/>
        </p:nvSpPr>
        <p:spPr>
          <a:xfrm>
            <a:off x="951249" y="955217"/>
            <a:ext cx="1060547" cy="369332"/>
          </a:xfrm>
          <a:prstGeom prst="rect">
            <a:avLst/>
          </a:prstGeom>
          <a:noFill/>
        </p:spPr>
        <p:txBody>
          <a:bodyPr wrap="none" lIns="121920" tIns="60960" rIns="121920" bIns="60960" rtlCol="0" anchor="t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M 1X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6B3E72-CD80-DBF2-B8F2-0309F5C40DE7}"/>
              </a:ext>
            </a:extLst>
          </p:cNvPr>
          <p:cNvSpPr txBox="1"/>
          <p:nvPr/>
        </p:nvSpPr>
        <p:spPr>
          <a:xfrm>
            <a:off x="0" y="34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sz="1800" kern="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6 (live</a:t>
            </a:r>
            <a:r>
              <a:rPr lang="en-US" kern="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0884234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0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6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16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16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9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0" fill="hold">
                      <p:stCondLst>
                        <p:cond delay="0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3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seq concurrent="1" nextAc="seek">
              <p:cTn id="24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5" fill="hold">
                      <p:stCondLst>
                        <p:cond delay="0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8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29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30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31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2" fill="hold">
                      <p:stCondLst>
                        <p:cond delay="0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5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41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4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6</TotalTime>
  <Words>133</Words>
  <Application>Microsoft Macintosh PowerPoint</Application>
  <PresentationFormat>Widescreen</PresentationFormat>
  <Paragraphs>64</Paragraphs>
  <Slides>2</Slides>
  <Notes>2</Notes>
  <HiddenSlides>0</HiddenSlides>
  <MMClips>4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ttacharyya, Raja,Ph.D.</dc:creator>
  <cp:lastModifiedBy>Bhattacharyya, Raja,Ph.D.</cp:lastModifiedBy>
  <cp:revision>66</cp:revision>
  <dcterms:created xsi:type="dcterms:W3CDTF">2024-06-11T18:29:16Z</dcterms:created>
  <dcterms:modified xsi:type="dcterms:W3CDTF">2024-09-15T23:53:52Z</dcterms:modified>
</cp:coreProperties>
</file>